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3" d="100"/>
          <a:sy n="113" d="100"/>
        </p:scale>
        <p:origin x="680" y="-17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064CE8-2F1D-4CC1-BD0F-22C348CF3DDE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4F77F-A498-4D76-BAEB-87ECA8840D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1362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064CE8-2F1D-4CC1-BD0F-22C348CF3DDE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4F77F-A498-4D76-BAEB-87ECA8840D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1151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064CE8-2F1D-4CC1-BD0F-22C348CF3DDE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4F77F-A498-4D76-BAEB-87ECA8840D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41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064CE8-2F1D-4CC1-BD0F-22C348CF3DDE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4F77F-A498-4D76-BAEB-87ECA8840D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6184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5333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186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064CE8-2F1D-4CC1-BD0F-22C348CF3DDE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4F77F-A498-4D76-BAEB-87ECA8840D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294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3733"/>
            </a:lvl1pPr>
            <a:lvl2pPr>
              <a:defRPr sz="3200"/>
            </a:lvl2pPr>
            <a:lvl3pPr>
              <a:defRPr sz="2667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064CE8-2F1D-4CC1-BD0F-22C348CF3DDE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4F77F-A498-4D76-BAEB-87ECA8840D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673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3200"/>
            </a:lvl1pPr>
            <a:lvl2pPr>
              <a:defRPr sz="2667"/>
            </a:lvl2pPr>
            <a:lvl3pPr>
              <a:defRPr sz="2400"/>
            </a:lvl3pPr>
            <a:lvl4pPr>
              <a:defRPr sz="2133"/>
            </a:lvl4pPr>
            <a:lvl5pPr>
              <a:defRPr sz="2133"/>
            </a:lvl5pPr>
            <a:lvl6pPr>
              <a:defRPr sz="2133"/>
            </a:lvl6pPr>
            <a:lvl7pPr>
              <a:defRPr sz="2133"/>
            </a:lvl7pPr>
            <a:lvl8pPr>
              <a:defRPr sz="2133"/>
            </a:lvl8pPr>
            <a:lvl9pPr>
              <a:defRPr sz="2133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064CE8-2F1D-4CC1-BD0F-22C348CF3DDE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4F77F-A498-4D76-BAEB-87ECA8840D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12174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064CE8-2F1D-4CC1-BD0F-22C348CF3DDE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4F77F-A498-4D76-BAEB-87ECA8840D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06145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064CE8-2F1D-4CC1-BD0F-22C348CF3DDE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4F77F-A498-4D76-BAEB-87ECA8840D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36411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064CE8-2F1D-4CC1-BD0F-22C348CF3DDE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4F77F-A498-4D76-BAEB-87ECA8840D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42337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667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867"/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064CE8-2F1D-4CC1-BD0F-22C348CF3DDE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F4F77F-A498-4D76-BAEB-87ECA8840D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89535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064CE8-2F1D-4CC1-BD0F-22C348CF3DDE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F4F77F-A498-4D76-BAEB-87ECA8840DC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21021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19170" rtl="0" eaLnBrk="1" latinLnBrk="0" hangingPunct="1"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189" indent="-457189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1pPr>
      <a:lvl2pPr marL="990575" indent="-380990" algn="l" defTabSz="1219170" rtl="0" eaLnBrk="1" latinLnBrk="0" hangingPunct="1">
        <a:spcBef>
          <a:spcPct val="20000"/>
        </a:spcBef>
        <a:buFont typeface="Arial" panose="020B0604020202020204" pitchFamily="34" charset="0"/>
        <a:buChar char="–"/>
        <a:defRPr sz="3733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–"/>
        <a:defRPr sz="2667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»"/>
        <a:defRPr sz="2667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spcBef>
          <a:spcPct val="20000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47750178"/>
              </p:ext>
            </p:extLst>
          </p:nvPr>
        </p:nvGraphicFramePr>
        <p:xfrm>
          <a:off x="536579" y="1265852"/>
          <a:ext cx="2025634" cy="14639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19" name="Prism 8" r:id="rId3" imgW="4220070" imgH="3049959" progId="Prism8.Document">
                  <p:embed/>
                </p:oleObj>
              </mc:Choice>
              <mc:Fallback>
                <p:oleObj name="Prism 8" r:id="rId3" imgW="4220070" imgH="3049959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36579" y="1265852"/>
                        <a:ext cx="2025634" cy="14639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85829207"/>
              </p:ext>
            </p:extLst>
          </p:nvPr>
        </p:nvGraphicFramePr>
        <p:xfrm>
          <a:off x="4679966" y="1265853"/>
          <a:ext cx="2025634" cy="14639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20" name="Prism 6" r:id="rId5" imgW="4220070" imgH="3049959" progId="Prism6.Document">
                  <p:embed/>
                </p:oleObj>
              </mc:Choice>
              <mc:Fallback>
                <p:oleObj name="Prism 6" r:id="rId5" imgW="4220070" imgH="3049959" progId="Prism6.Document">
                  <p:embed/>
                  <p:pic>
                    <p:nvPicPr>
                      <p:cNvPr id="3" name="Objec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79966" y="1265853"/>
                        <a:ext cx="2025634" cy="14639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2340516"/>
              </p:ext>
            </p:extLst>
          </p:nvPr>
        </p:nvGraphicFramePr>
        <p:xfrm>
          <a:off x="2608272" y="1265853"/>
          <a:ext cx="2025634" cy="14639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21" name="Prism 8" r:id="rId7" imgW="4220070" imgH="3049959" progId="Prism8.Document">
                  <p:embed/>
                </p:oleObj>
              </mc:Choice>
              <mc:Fallback>
                <p:oleObj name="Prism 8" r:id="rId7" imgW="4220070" imgH="3049959" progId="Prism8.Document">
                  <p:embed/>
                  <p:pic>
                    <p:nvPicPr>
                      <p:cNvPr id="4" name="Objec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08272" y="1265853"/>
                        <a:ext cx="2025634" cy="14639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86969268"/>
              </p:ext>
            </p:extLst>
          </p:nvPr>
        </p:nvGraphicFramePr>
        <p:xfrm>
          <a:off x="536579" y="3531214"/>
          <a:ext cx="2025634" cy="14639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22" name="Prism 6" r:id="rId9" imgW="4220070" imgH="3049959" progId="Prism6.Document">
                  <p:embed/>
                </p:oleObj>
              </mc:Choice>
              <mc:Fallback>
                <p:oleObj name="Prism 6" r:id="rId9" imgW="4220070" imgH="3049959" progId="Prism6.Document">
                  <p:embed/>
                  <p:pic>
                    <p:nvPicPr>
                      <p:cNvPr id="6" name="Object 5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36579" y="3531214"/>
                        <a:ext cx="2025634" cy="146398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4288846"/>
              </p:ext>
            </p:extLst>
          </p:nvPr>
        </p:nvGraphicFramePr>
        <p:xfrm>
          <a:off x="4679966" y="3531214"/>
          <a:ext cx="2025634" cy="14639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23" name="Prism 6" r:id="rId11" imgW="4220070" imgH="3049959" progId="Prism6.Document">
                  <p:embed/>
                </p:oleObj>
              </mc:Choice>
              <mc:Fallback>
                <p:oleObj name="Prism 6" r:id="rId11" imgW="4220070" imgH="3049959" progId="Prism6.Document">
                  <p:embed/>
                  <p:pic>
                    <p:nvPicPr>
                      <p:cNvPr id="7" name="Object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679966" y="3531214"/>
                        <a:ext cx="2025634" cy="14639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798012"/>
              </p:ext>
            </p:extLst>
          </p:nvPr>
        </p:nvGraphicFramePr>
        <p:xfrm>
          <a:off x="2608272" y="3531214"/>
          <a:ext cx="2025634" cy="146398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324" name="Prism 8" r:id="rId13" imgW="4220070" imgH="3049959" progId="Prism8.Document">
                  <p:embed/>
                </p:oleObj>
              </mc:Choice>
              <mc:Fallback>
                <p:oleObj name="Prism 8" r:id="rId13" imgW="4220070" imgH="3049959" progId="Prism8.Document">
                  <p:embed/>
                  <p:pic>
                    <p:nvPicPr>
                      <p:cNvPr id="8" name="Objec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608272" y="3531214"/>
                        <a:ext cx="2025634" cy="146398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17"/>
          <p:cNvSpPr txBox="1"/>
          <p:nvPr/>
        </p:nvSpPr>
        <p:spPr>
          <a:xfrm>
            <a:off x="258966" y="990600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A</a:t>
            </a:r>
            <a:endParaRPr lang="en-US" sz="1200" dirty="0"/>
          </a:p>
        </p:txBody>
      </p:sp>
      <p:sp>
        <p:nvSpPr>
          <p:cNvPr id="19" name="TextBox 18"/>
          <p:cNvSpPr txBox="1"/>
          <p:nvPr/>
        </p:nvSpPr>
        <p:spPr>
          <a:xfrm>
            <a:off x="258966" y="3228201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381000" y="5562600"/>
            <a:ext cx="61721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Supplementary </a:t>
            </a:r>
            <a:r>
              <a:rPr lang="en-US" sz="1200" b="1"/>
              <a:t>Figure </a:t>
            </a:r>
            <a:r>
              <a:rPr lang="en-US" sz="1200" b="1" smtClean="0"/>
              <a:t>3.</a:t>
            </a:r>
            <a:r>
              <a:rPr lang="en-US" sz="1200" smtClean="0"/>
              <a:t> </a:t>
            </a:r>
            <a:r>
              <a:rPr lang="en-US" sz="1200" dirty="0"/>
              <a:t>Individual IC</a:t>
            </a:r>
            <a:r>
              <a:rPr lang="en-US" sz="1200" baseline="-25000" dirty="0"/>
              <a:t>50</a:t>
            </a:r>
            <a:r>
              <a:rPr lang="en-US" sz="1200" dirty="0"/>
              <a:t> values for A485, </a:t>
            </a:r>
            <a:r>
              <a:rPr lang="en-US" sz="1200" dirty="0" smtClean="0">
                <a:solidFill>
                  <a:srgbClr val="FF0000"/>
                </a:solidFill>
              </a:rPr>
              <a:t>Comp 13 </a:t>
            </a:r>
            <a:r>
              <a:rPr lang="en-US" sz="1200" dirty="0"/>
              <a:t>and iP300w in NCC-CDS-X1 cells at 48 (A) and 98 (B) hours of treatment.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381000" y="304800"/>
            <a:ext cx="170617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Supplementary Figure 3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7323298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</TotalTime>
  <Words>37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Office Theme</vt:lpstr>
      <vt:lpstr>Prism 8</vt:lpstr>
      <vt:lpstr>Prism 6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balab</dc:creator>
  <cp:lastModifiedBy>Darko Bosnakovski</cp:lastModifiedBy>
  <cp:revision>15</cp:revision>
  <dcterms:created xsi:type="dcterms:W3CDTF">2021-01-16T00:18:11Z</dcterms:created>
  <dcterms:modified xsi:type="dcterms:W3CDTF">2021-08-26T17:27:55Z</dcterms:modified>
</cp:coreProperties>
</file>